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8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79294" autoAdjust="0"/>
  </p:normalViewPr>
  <p:slideViewPr>
    <p:cSldViewPr>
      <p:cViewPr>
        <p:scale>
          <a:sx n="91" d="100"/>
          <a:sy n="91" d="100"/>
        </p:scale>
        <p:origin x="-58" y="11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FCEF4E-2DD9-4CDE-A225-EE49372CFCCD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447953-45FE-4FD3-85D8-667E69F9041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78530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447953-45FE-4FD3-85D8-667E69F9041A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0886283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000635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1365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8602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936651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315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3334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73026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88006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15857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029711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696402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353C6-D15F-410C-90A8-B8EFFAAFDC54}" type="datetimeFigureOut">
              <a:rPr lang="ko-KR" altLang="en-US" smtClean="0"/>
              <a:pPr/>
              <a:t>2022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213651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33312" y="864706"/>
            <a:ext cx="6408712" cy="40469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직사각형 16"/>
          <p:cNvSpPr/>
          <p:nvPr/>
        </p:nvSpPr>
        <p:spPr>
          <a:xfrm>
            <a:off x="5940152" y="774131"/>
            <a:ext cx="432048" cy="17465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>
            <a:off x="5940152" y="1018149"/>
            <a:ext cx="432048" cy="15609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6372200" y="735087"/>
            <a:ext cx="1440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Left hemisphere</a:t>
            </a:r>
          </a:p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Right hemisphere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5536" y="5013176"/>
            <a:ext cx="849694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plementary figure 1.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Comparison of the fractional anisotropy values in the superior longitudinal fasciculus subcomponents between the left and right hemispheres by independent t-test </a:t>
            </a: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FAs of left SLF I was significantly higher than that of right SLF I (t = 4.92, p &lt; 0.001). However, FAs of the left SLF II and AF were significantly lower than those of the right SLF II and AF (t = −15.18, p &lt; 0.001 and t = −5.86, p &lt; 0.001, respectively). </a:t>
            </a: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(FA, fractional anisotropy; SLF, superior longitudinal fasciculus; AF,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rcuat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fasciculus) </a:t>
            </a: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**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Bonferroni’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correction for multiple comparisons at p &lt; 0.0125</a:t>
            </a:r>
          </a:p>
          <a:p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627784" y="1628800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Left &gt; Right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23928" y="1393031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Left &lt; Right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516216" y="1321023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Left &lt; Right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299141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90</TotalTime>
  <Words>132</Words>
  <Application>Microsoft Office PowerPoint</Application>
  <PresentationFormat>화면 슬라이드 쇼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a</dc:creator>
  <cp:lastModifiedBy>Sra Jung</cp:lastModifiedBy>
  <cp:revision>192</cp:revision>
  <dcterms:created xsi:type="dcterms:W3CDTF">2020-04-21T02:26:32Z</dcterms:created>
  <dcterms:modified xsi:type="dcterms:W3CDTF">2022-03-01T02:17:04Z</dcterms:modified>
</cp:coreProperties>
</file>